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60" r:id="rId3"/>
    <p:sldId id="256" r:id="rId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9"/>
  </p:normalViewPr>
  <p:slideViewPr>
    <p:cSldViewPr snapToGrid="0" snapToObjects="1" showGuides="1">
      <p:cViewPr varScale="1">
        <p:scale>
          <a:sx n="97" d="100"/>
          <a:sy n="97" d="100"/>
        </p:scale>
        <p:origin x="1752" y="20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sltillmann/ECU%20/Studies/Cooperation%20Michael%20Merz/DILI-CAT%204-Drug%20Analysis%20Submission%20Files/5%20PLos%20One/Underlaying%20dataset,%20DILI-CAT%204%20drugs,%20excel%20based%20with.exc%2005-13-202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sltillmann/ECU%20/Studies/Cooperation%20Michael%20Merz/DILI-CAT%204-Drug%20Analysis%20Submission%20Files/5%20PLos%20One/Underlaying%20dataset,%20DILI-CAT%204%20drugs,%20excel%20based%20with.exc%2005-13-202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sltillmann/ECU%20/Studies/Cooperation%20Michael%20Merz/DILI-CAT%204-Drug%20Analysis%20Submission%20Files/5%20PLos%20One/Underlaying%20dataset,%20DILI-CAT%204%20drugs,%20excel%20based%20with.exc%2002-06-202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8310983358781157E-2"/>
          <c:y val="2.9520397807056162E-2"/>
          <c:w val="0.94583472450869288"/>
          <c:h val="0.7695487920040697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2a'!$H$4</c:f>
              <c:strCache>
                <c:ptCount val="1"/>
                <c:pt idx="0">
                  <c:v>AMX-CLA (n=35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Figure 2a'!$G$5:$G$29</c:f>
              <c:strCach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strCache>
            </c:strRef>
          </c:cat>
          <c:val>
            <c:numRef>
              <c:f>'Figure 2a'!$H$5:$H$29</c:f>
              <c:numCache>
                <c:formatCode>###0</c:formatCode>
                <c:ptCount val="25"/>
                <c:pt idx="0">
                  <c:v>7</c:v>
                </c:pt>
                <c:pt idx="1">
                  <c:v>0</c:v>
                </c:pt>
                <c:pt idx="2">
                  <c:v>6</c:v>
                </c:pt>
                <c:pt idx="3">
                  <c:v>0</c:v>
                </c:pt>
                <c:pt idx="4">
                  <c:v>4</c:v>
                </c:pt>
                <c:pt idx="5">
                  <c:v>2</c:v>
                </c:pt>
                <c:pt idx="6">
                  <c:v>3</c:v>
                </c:pt>
                <c:pt idx="7">
                  <c:v>1</c:v>
                </c:pt>
                <c:pt idx="8">
                  <c:v>5</c:v>
                </c:pt>
                <c:pt idx="9">
                  <c:v>0</c:v>
                </c:pt>
                <c:pt idx="10">
                  <c:v>1</c:v>
                </c:pt>
                <c:pt idx="11">
                  <c:v>3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110-3343-8D1A-8C9983C0F8CE}"/>
            </c:ext>
          </c:extLst>
        </c:ser>
        <c:ser>
          <c:idx val="1"/>
          <c:order val="1"/>
          <c:tx>
            <c:strRef>
              <c:f>'Figure 2a'!$I$4</c:f>
              <c:strCache>
                <c:ptCount val="1"/>
                <c:pt idx="0">
                  <c:v>Cyproterone (N=2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Figure 2a'!$G$5:$G$29</c:f>
              <c:strCach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strCache>
            </c:strRef>
          </c:cat>
          <c:val>
            <c:numRef>
              <c:f>'Figure 2a'!$I$5:$I$29</c:f>
              <c:numCache>
                <c:formatCode>###0</c:formatCode>
                <c:ptCount val="2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1</c:v>
                </c:pt>
                <c:pt idx="15">
                  <c:v>1</c:v>
                </c:pt>
                <c:pt idx="16">
                  <c:v>0</c:v>
                </c:pt>
                <c:pt idx="17">
                  <c:v>8</c:v>
                </c:pt>
                <c:pt idx="18">
                  <c:v>5</c:v>
                </c:pt>
                <c:pt idx="19">
                  <c:v>2</c:v>
                </c:pt>
                <c:pt idx="20">
                  <c:v>0</c:v>
                </c:pt>
                <c:pt idx="21">
                  <c:v>2</c:v>
                </c:pt>
                <c:pt idx="22">
                  <c:v>1</c:v>
                </c:pt>
                <c:pt idx="23">
                  <c:v>1</c:v>
                </c:pt>
                <c:pt idx="2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110-3343-8D1A-8C9983C0F8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09841104"/>
        <c:axId val="609843400"/>
      </c:barChart>
      <c:catAx>
        <c:axId val="609841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9843400"/>
        <c:crosses val="autoZero"/>
        <c:auto val="1"/>
        <c:lblAlgn val="ctr"/>
        <c:lblOffset val="100"/>
        <c:noMultiLvlLbl val="0"/>
      </c:catAx>
      <c:valAx>
        <c:axId val="6098434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98411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7400405397427236E-2"/>
          <c:y val="2.4650990848077019E-2"/>
          <c:w val="0.95706725392330583"/>
          <c:h val="0.7869700897193722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2b'!$H$4</c:f>
              <c:strCache>
                <c:ptCount val="1"/>
                <c:pt idx="0">
                  <c:v>AMX-CLA (n=35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Figure 2b'!$G$5:$G$29</c:f>
              <c:strCach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strCache>
            </c:strRef>
          </c:cat>
          <c:val>
            <c:numRef>
              <c:f>'Figure 2b'!$H$5:$H$29</c:f>
              <c:numCache>
                <c:formatCode>General</c:formatCode>
                <c:ptCount val="25"/>
                <c:pt idx="0" formatCode="###0">
                  <c:v>7</c:v>
                </c:pt>
                <c:pt idx="2" formatCode="###0">
                  <c:v>3</c:v>
                </c:pt>
                <c:pt idx="3" formatCode="###0">
                  <c:v>2</c:v>
                </c:pt>
                <c:pt idx="4" formatCode="###0">
                  <c:v>8</c:v>
                </c:pt>
                <c:pt idx="5" formatCode="###0">
                  <c:v>2</c:v>
                </c:pt>
                <c:pt idx="6" formatCode="###0">
                  <c:v>2</c:v>
                </c:pt>
                <c:pt idx="7" formatCode="###0">
                  <c:v>2</c:v>
                </c:pt>
                <c:pt idx="8" formatCode="###0">
                  <c:v>3</c:v>
                </c:pt>
                <c:pt idx="9" formatCode="###0">
                  <c:v>0</c:v>
                </c:pt>
                <c:pt idx="10" formatCode="###0">
                  <c:v>1</c:v>
                </c:pt>
                <c:pt idx="11" formatCode="###0">
                  <c:v>1</c:v>
                </c:pt>
                <c:pt idx="12" formatCode="###0">
                  <c:v>0</c:v>
                </c:pt>
                <c:pt idx="13" formatCode="###0">
                  <c:v>2</c:v>
                </c:pt>
                <c:pt idx="15" formatCode="###0">
                  <c:v>1</c:v>
                </c:pt>
                <c:pt idx="16" formatCode="###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FFF-1B43-8FEA-BA6B02D8FFFA}"/>
            </c:ext>
          </c:extLst>
        </c:ser>
        <c:ser>
          <c:idx val="1"/>
          <c:order val="1"/>
          <c:tx>
            <c:strRef>
              <c:f>'Figure 2b'!$I$4</c:f>
              <c:strCache>
                <c:ptCount val="1"/>
                <c:pt idx="0">
                  <c:v>Cefazolin (N=19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Figure 2b'!$G$5:$G$29</c:f>
              <c:strCach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strCache>
            </c:strRef>
          </c:cat>
          <c:val>
            <c:numRef>
              <c:f>'Figure 2b'!$I$5:$I$29</c:f>
              <c:numCache>
                <c:formatCode>General</c:formatCode>
                <c:ptCount val="25"/>
                <c:pt idx="0" formatCode="###0">
                  <c:v>3</c:v>
                </c:pt>
                <c:pt idx="2" formatCode="###0">
                  <c:v>1</c:v>
                </c:pt>
                <c:pt idx="3" formatCode="###0">
                  <c:v>0</c:v>
                </c:pt>
                <c:pt idx="4" formatCode="###0">
                  <c:v>8</c:v>
                </c:pt>
                <c:pt idx="5" formatCode="###0">
                  <c:v>0</c:v>
                </c:pt>
                <c:pt idx="6" formatCode="###0">
                  <c:v>2</c:v>
                </c:pt>
                <c:pt idx="7" formatCode="###0">
                  <c:v>1</c:v>
                </c:pt>
                <c:pt idx="8" formatCode="###0">
                  <c:v>1</c:v>
                </c:pt>
                <c:pt idx="9" formatCode="###0">
                  <c:v>1</c:v>
                </c:pt>
                <c:pt idx="10" formatCode="###0">
                  <c:v>1</c:v>
                </c:pt>
                <c:pt idx="11" formatCode="###0">
                  <c:v>0</c:v>
                </c:pt>
                <c:pt idx="12" formatCode="###0">
                  <c:v>0</c:v>
                </c:pt>
                <c:pt idx="13" formatCode="###0">
                  <c:v>0</c:v>
                </c:pt>
                <c:pt idx="15" formatCode="###0">
                  <c:v>1</c:v>
                </c:pt>
                <c:pt idx="16" formatCode="###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FFF-1B43-8FEA-BA6B02D8FF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7241648"/>
        <c:axId val="677240336"/>
      </c:barChart>
      <c:catAx>
        <c:axId val="677241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7240336"/>
        <c:crosses val="autoZero"/>
        <c:auto val="1"/>
        <c:lblAlgn val="ctr"/>
        <c:lblOffset val="100"/>
        <c:noMultiLvlLbl val="0"/>
      </c:catAx>
      <c:valAx>
        <c:axId val="677240336"/>
        <c:scaling>
          <c:orientation val="minMax"/>
          <c:max val="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72416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0942382860607127E-2"/>
          <c:y val="3.1617548478054286E-2"/>
          <c:w val="0.94376459651494282"/>
          <c:h val="0.772395608917415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2c'!$H$4</c:f>
              <c:strCache>
                <c:ptCount val="1"/>
                <c:pt idx="0">
                  <c:v>AMX-CLA (n=35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Figure 2c'!$G$5:$G$27</c:f>
              <c:numCache>
                <c:formatCode>General</c:formatCode>
                <c:ptCount val="23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</c:numCache>
            </c:numRef>
          </c:cat>
          <c:val>
            <c:numRef>
              <c:f>'Figure 2c'!$H$5:$H$27</c:f>
              <c:numCache>
                <c:formatCode>General</c:formatCode>
                <c:ptCount val="23"/>
                <c:pt idx="0" formatCode="###0">
                  <c:v>7</c:v>
                </c:pt>
                <c:pt idx="2" formatCode="###0">
                  <c:v>7</c:v>
                </c:pt>
                <c:pt idx="3" formatCode="###0">
                  <c:v>2</c:v>
                </c:pt>
                <c:pt idx="4" formatCode="###0">
                  <c:v>3</c:v>
                </c:pt>
                <c:pt idx="6" formatCode="###0">
                  <c:v>4</c:v>
                </c:pt>
                <c:pt idx="7" formatCode="###0">
                  <c:v>1</c:v>
                </c:pt>
                <c:pt idx="8" formatCode="###0">
                  <c:v>2</c:v>
                </c:pt>
                <c:pt idx="10" formatCode="###0">
                  <c:v>2</c:v>
                </c:pt>
                <c:pt idx="11" formatCode="###0">
                  <c:v>2</c:v>
                </c:pt>
                <c:pt idx="12" formatCode="###0">
                  <c:v>0</c:v>
                </c:pt>
                <c:pt idx="13" formatCode="###0">
                  <c:v>3</c:v>
                </c:pt>
                <c:pt idx="14" formatCode="###0">
                  <c:v>1</c:v>
                </c:pt>
                <c:pt idx="15" formatCode="###0">
                  <c:v>1</c:v>
                </c:pt>
                <c:pt idx="16" formatCode="###0">
                  <c:v>0</c:v>
                </c:pt>
                <c:pt idx="17" formatCode="###0">
                  <c:v>0</c:v>
                </c:pt>
                <c:pt idx="18" formatCode="###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547-E144-8391-60088AA999DD}"/>
            </c:ext>
          </c:extLst>
        </c:ser>
        <c:ser>
          <c:idx val="1"/>
          <c:order val="1"/>
          <c:tx>
            <c:strRef>
              <c:f>'Figure 2c'!$I$4</c:f>
              <c:strCache>
                <c:ptCount val="1"/>
                <c:pt idx="0">
                  <c:v>Polygonum_Multiforum (N=18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Figure 2c'!$G$5:$G$27</c:f>
              <c:numCache>
                <c:formatCode>General</c:formatCode>
                <c:ptCount val="23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</c:numCache>
            </c:numRef>
          </c:cat>
          <c:val>
            <c:numRef>
              <c:f>'Figure 2c'!$I$5:$I$27</c:f>
              <c:numCache>
                <c:formatCode>General</c:formatCode>
                <c:ptCount val="23"/>
                <c:pt idx="0" formatCode="###0">
                  <c:v>0</c:v>
                </c:pt>
                <c:pt idx="2" formatCode="###0">
                  <c:v>0</c:v>
                </c:pt>
                <c:pt idx="3" formatCode="###0">
                  <c:v>0</c:v>
                </c:pt>
                <c:pt idx="4" formatCode="###0">
                  <c:v>0</c:v>
                </c:pt>
                <c:pt idx="6" formatCode="###0">
                  <c:v>0</c:v>
                </c:pt>
                <c:pt idx="7" formatCode="###0">
                  <c:v>0</c:v>
                </c:pt>
                <c:pt idx="8" formatCode="###0">
                  <c:v>1</c:v>
                </c:pt>
                <c:pt idx="10" formatCode="###0">
                  <c:v>3</c:v>
                </c:pt>
                <c:pt idx="11" formatCode="###0">
                  <c:v>1</c:v>
                </c:pt>
                <c:pt idx="12" formatCode="###0">
                  <c:v>3</c:v>
                </c:pt>
                <c:pt idx="13" formatCode="###0">
                  <c:v>0</c:v>
                </c:pt>
                <c:pt idx="14" formatCode="###0">
                  <c:v>4</c:v>
                </c:pt>
                <c:pt idx="15" formatCode="###0">
                  <c:v>0</c:v>
                </c:pt>
                <c:pt idx="16" formatCode="###0">
                  <c:v>3</c:v>
                </c:pt>
                <c:pt idx="17" formatCode="###0">
                  <c:v>1</c:v>
                </c:pt>
                <c:pt idx="18" formatCode="###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547-E144-8391-60088AA999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7706952"/>
        <c:axId val="621811152"/>
      </c:barChart>
      <c:catAx>
        <c:axId val="617706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1811152"/>
        <c:crosses val="autoZero"/>
        <c:auto val="1"/>
        <c:lblAlgn val="ctr"/>
        <c:lblOffset val="100"/>
        <c:noMultiLvlLbl val="0"/>
      </c:catAx>
      <c:valAx>
        <c:axId val="6218111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77069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583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083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310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23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537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479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049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884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019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886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665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229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A64F14D6-71A1-412D-9754-EAFC2F044F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2756580"/>
              </p:ext>
            </p:extLst>
          </p:nvPr>
        </p:nvGraphicFramePr>
        <p:xfrm>
          <a:off x="742122" y="768625"/>
          <a:ext cx="8811494" cy="59502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D697D71-2F15-5B40-90EB-3A36CD233D83}"/>
              </a:ext>
            </a:extLst>
          </p:cNvPr>
          <p:cNvSpPr txBox="1"/>
          <p:nvPr/>
        </p:nvSpPr>
        <p:spPr>
          <a:xfrm rot="16200000">
            <a:off x="-416689" y="2964875"/>
            <a:ext cx="1756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mber of cas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3C3AB7-EE57-4B46-AFF1-3E54E78BC5FF}"/>
              </a:ext>
            </a:extLst>
          </p:cNvPr>
          <p:cNvSpPr txBox="1"/>
          <p:nvPr/>
        </p:nvSpPr>
        <p:spPr>
          <a:xfrm>
            <a:off x="124685" y="1062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3D62DCD-82C3-4A44-87FB-F9F541E57941}"/>
              </a:ext>
            </a:extLst>
          </p:cNvPr>
          <p:cNvSpPr txBox="1"/>
          <p:nvPr/>
        </p:nvSpPr>
        <p:spPr>
          <a:xfrm>
            <a:off x="2476499" y="5919477"/>
            <a:ext cx="4953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/>
              <a:t>Numeric AMX/CLA-DILI-CAT scor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987D6B2-E7A1-714D-A771-EFD60E7D1D74}"/>
              </a:ext>
            </a:extLst>
          </p:cNvPr>
          <p:cNvSpPr txBox="1"/>
          <p:nvPr/>
        </p:nvSpPr>
        <p:spPr>
          <a:xfrm>
            <a:off x="598760" y="263233"/>
            <a:ext cx="8811494" cy="3877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9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atency weighted AMX/CLA-DII-CAT comparing AMX/CLA (n=35) to cyproterone (n=22) </a:t>
            </a:r>
          </a:p>
        </p:txBody>
      </p:sp>
    </p:spTree>
    <p:extLst>
      <p:ext uri="{BB962C8B-B14F-4D97-AF65-F5344CB8AC3E}">
        <p14:creationId xmlns:p14="http://schemas.microsoft.com/office/powerpoint/2010/main" val="18103270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24C07B0B-2027-4BA1-B758-924A092AAD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0177583"/>
              </p:ext>
            </p:extLst>
          </p:nvPr>
        </p:nvGraphicFramePr>
        <p:xfrm>
          <a:off x="634773" y="861391"/>
          <a:ext cx="8994137" cy="56671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D697D71-2F15-5B40-90EB-3A36CD233D83}"/>
              </a:ext>
            </a:extLst>
          </p:cNvPr>
          <p:cNvSpPr txBox="1"/>
          <p:nvPr/>
        </p:nvSpPr>
        <p:spPr>
          <a:xfrm rot="16200000">
            <a:off x="-416689" y="2964875"/>
            <a:ext cx="1756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mber of cas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3C3AB7-EE57-4B46-AFF1-3E54E78BC5FF}"/>
              </a:ext>
            </a:extLst>
          </p:cNvPr>
          <p:cNvSpPr txBox="1"/>
          <p:nvPr/>
        </p:nvSpPr>
        <p:spPr>
          <a:xfrm>
            <a:off x="124685" y="1062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F10570A-EBEF-AE44-972C-BAFCB294774A}"/>
              </a:ext>
            </a:extLst>
          </p:cNvPr>
          <p:cNvSpPr txBox="1"/>
          <p:nvPr/>
        </p:nvSpPr>
        <p:spPr>
          <a:xfrm>
            <a:off x="2476499" y="5821286"/>
            <a:ext cx="4953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/>
              <a:t>Numeric AMX/CLA-DILI-CAT scor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648E03A-058F-A340-B0DF-C154E4940C9E}"/>
              </a:ext>
            </a:extLst>
          </p:cNvPr>
          <p:cNvSpPr txBox="1"/>
          <p:nvPr/>
        </p:nvSpPr>
        <p:spPr>
          <a:xfrm>
            <a:off x="534176" y="263233"/>
            <a:ext cx="9094734" cy="3877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9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AST/ALT ratio weighted AMX/CLA-DII-CAT comparing AMX/CLA (n=35) to cefazoline (n=19) </a:t>
            </a:r>
          </a:p>
        </p:txBody>
      </p:sp>
      <p:sp>
        <p:nvSpPr>
          <p:cNvPr id="7" name="TextBox 61">
            <a:extLst>
              <a:ext uri="{FF2B5EF4-FFF2-40B4-BE49-F238E27FC236}">
                <a16:creationId xmlns:a16="http://schemas.microsoft.com/office/drawing/2014/main" id="{EA27FB77-B841-7F48-B4F4-7EA524195C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4773" y="5914680"/>
            <a:ext cx="25039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24549702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75AF2A08-F4F6-4EB4-ADE0-9A38FD55FC2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8072477"/>
              </p:ext>
            </p:extLst>
          </p:nvPr>
        </p:nvGraphicFramePr>
        <p:xfrm>
          <a:off x="646423" y="789709"/>
          <a:ext cx="9134886" cy="59297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CC0993B-A034-F74A-9079-A89CF7B2AC4D}"/>
              </a:ext>
            </a:extLst>
          </p:cNvPr>
          <p:cNvSpPr txBox="1"/>
          <p:nvPr/>
        </p:nvSpPr>
        <p:spPr>
          <a:xfrm rot="16200000">
            <a:off x="-416689" y="2964875"/>
            <a:ext cx="1756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mber of cas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C9C57FA-FA08-3249-9D98-257E6D79AC0B}"/>
              </a:ext>
            </a:extLst>
          </p:cNvPr>
          <p:cNvSpPr txBox="1"/>
          <p:nvPr/>
        </p:nvSpPr>
        <p:spPr>
          <a:xfrm>
            <a:off x="124685" y="10627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C7046D5-5F3B-FC49-9519-D2AB2D6D5F0F}"/>
              </a:ext>
            </a:extLst>
          </p:cNvPr>
          <p:cNvSpPr txBox="1"/>
          <p:nvPr/>
        </p:nvSpPr>
        <p:spPr>
          <a:xfrm>
            <a:off x="969821" y="263233"/>
            <a:ext cx="7994072" cy="3877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9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R-value weight AMX/CLA-DII-CAT comparing AMX/CLA (n=35) to PM (n=18)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E8F665D-6C69-E84F-8BF7-2095CC4D0DB3}"/>
              </a:ext>
            </a:extLst>
          </p:cNvPr>
          <p:cNvSpPr txBox="1"/>
          <p:nvPr/>
        </p:nvSpPr>
        <p:spPr>
          <a:xfrm>
            <a:off x="2476499" y="5890561"/>
            <a:ext cx="4953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/>
              <a:t>Numeric AMX/CLA-DILI-CAT score</a:t>
            </a:r>
          </a:p>
        </p:txBody>
      </p:sp>
    </p:spTree>
    <p:extLst>
      <p:ext uri="{BB962C8B-B14F-4D97-AF65-F5344CB8AC3E}">
        <p14:creationId xmlns:p14="http://schemas.microsoft.com/office/powerpoint/2010/main" val="680506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0</TotalTime>
  <Words>94</Words>
  <Application>Microsoft Macintosh PowerPoint</Application>
  <PresentationFormat>A4 Paper (210x297 mm)</PresentationFormat>
  <Paragraphs>1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s Tillmann</dc:creator>
  <cp:lastModifiedBy>Hans Tillmann</cp:lastModifiedBy>
  <cp:revision>13</cp:revision>
  <dcterms:created xsi:type="dcterms:W3CDTF">2022-04-18T11:51:12Z</dcterms:created>
  <dcterms:modified xsi:type="dcterms:W3CDTF">2022-05-19T17:47:10Z</dcterms:modified>
</cp:coreProperties>
</file>